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9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97" userDrawn="1">
          <p15:clr>
            <a:srgbClr val="A4A3A4"/>
          </p15:clr>
        </p15:guide>
        <p15:guide id="2" pos="211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F6673"/>
    <a:srgbClr val="99D09D"/>
    <a:srgbClr val="476B71"/>
    <a:srgbClr val="9A841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858"/>
    <p:restoredTop sz="95755"/>
  </p:normalViewPr>
  <p:slideViewPr>
    <p:cSldViewPr snapToGrid="0" showGuides="1">
      <p:cViewPr>
        <p:scale>
          <a:sx n="168" d="100"/>
          <a:sy n="168" d="100"/>
        </p:scale>
        <p:origin x="504" y="-232"/>
      </p:cViewPr>
      <p:guideLst>
        <p:guide orient="horz" pos="3097"/>
        <p:guide pos="211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x-non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34714DC-817F-B241-8636-373DE5205BA5}" type="datetimeFigureOut">
              <a:t>2024/05/17</a:t>
            </a:fld>
            <a:endParaRPr lang="x-non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x-non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x-non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x-non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2E6D04D-72CF-F347-842C-BE5A28EAEAC4}" type="slidenum"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738758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dirty="0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00EF1-5582-304D-9343-097D6F917E07}" type="datetimeFigureOut">
              <a:t>2024/05/17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D2B61-D2C4-954B-BDE3-274DB6F982C7}" type="slidenum"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17159611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00EF1-5582-304D-9343-097D6F917E07}" type="datetimeFigureOut">
              <a:t>2024/05/17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D2B61-D2C4-954B-BDE3-274DB6F982C7}" type="slidenum"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9388291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00EF1-5582-304D-9343-097D6F917E07}" type="datetimeFigureOut">
              <a:t>2024/05/17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D2B61-D2C4-954B-BDE3-274DB6F982C7}" type="slidenum"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32820982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00EF1-5582-304D-9343-097D6F917E07}" type="datetimeFigureOut">
              <a:t>2024/05/17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D2B61-D2C4-954B-BDE3-274DB6F982C7}" type="slidenum"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27874559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00EF1-5582-304D-9343-097D6F917E07}" type="datetimeFigureOut">
              <a:t>2024/05/17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D2B61-D2C4-954B-BDE3-274DB6F982C7}" type="slidenum"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27677504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00EF1-5582-304D-9343-097D6F917E07}" type="datetimeFigureOut">
              <a:t>2024/05/17</a:t>
            </a:fld>
            <a:endParaRPr lang="x-non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D2B61-D2C4-954B-BDE3-274DB6F982C7}" type="slidenum"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23827644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00EF1-5582-304D-9343-097D6F917E07}" type="datetimeFigureOut">
              <a:t>2024/05/17</a:t>
            </a:fld>
            <a:endParaRPr lang="x-non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D2B61-D2C4-954B-BDE3-274DB6F982C7}" type="slidenum"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34185786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00EF1-5582-304D-9343-097D6F917E07}" type="datetimeFigureOut">
              <a:t>2024/05/17</a:t>
            </a:fld>
            <a:endParaRPr lang="x-non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D2B61-D2C4-954B-BDE3-274DB6F982C7}" type="slidenum"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19947885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00EF1-5582-304D-9343-097D6F917E07}" type="datetimeFigureOut">
              <a:t>2024/05/17</a:t>
            </a:fld>
            <a:endParaRPr lang="x-non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D2B61-D2C4-954B-BDE3-274DB6F982C7}" type="slidenum"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21663962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00EF1-5582-304D-9343-097D6F917E07}" type="datetimeFigureOut">
              <a:t>2024/05/17</a:t>
            </a:fld>
            <a:endParaRPr lang="x-non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D2B61-D2C4-954B-BDE3-274DB6F982C7}" type="slidenum"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11087395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700EF1-5582-304D-9343-097D6F917E07}" type="datetimeFigureOut">
              <a:t>2024/05/17</a:t>
            </a:fld>
            <a:endParaRPr lang="x-non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x-non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1D2B61-D2C4-954B-BDE3-274DB6F982C7}" type="slidenum"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27634344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700EF1-5582-304D-9343-097D6F917E07}" type="datetimeFigureOut">
              <a:t>2024/05/17</a:t>
            </a:fld>
            <a:endParaRPr lang="x-non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x-non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1D2B61-D2C4-954B-BDE3-274DB6F982C7}" type="slidenum">
              <a:t>‹#›</a:t>
            </a:fld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42186165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テキスト ボックス 4">
            <a:extLst>
              <a:ext uri="{FF2B5EF4-FFF2-40B4-BE49-F238E27FC236}">
                <a16:creationId xmlns:a16="http://schemas.microsoft.com/office/drawing/2014/main" id="{DE5768D3-994D-CE6C-2288-827EF74752B7}"/>
              </a:ext>
            </a:extLst>
          </p:cNvPr>
          <p:cNvSpPr txBox="1"/>
          <p:nvPr/>
        </p:nvSpPr>
        <p:spPr>
          <a:xfrm>
            <a:off x="13156" y="6639870"/>
            <a:ext cx="922293" cy="3351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kumimoji="1" lang="ja-JP" altLang="en-US" sz="12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20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2131146E-01BD-FB32-A5CA-2259BCE5D724}"/>
              </a:ext>
            </a:extLst>
          </p:cNvPr>
          <p:cNvSpPr txBox="1"/>
          <p:nvPr/>
        </p:nvSpPr>
        <p:spPr>
          <a:xfrm>
            <a:off x="1423055" y="771099"/>
            <a:ext cx="6527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x-none" sz="1200" dirty="0">
                <a:latin typeface="Arial" panose="020B0604020202020204" pitchFamily="34" charset="0"/>
                <a:cs typeface="Arial" panose="020B0604020202020204" pitchFamily="34" charset="0"/>
              </a:rPr>
              <a:t>a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x-none" sz="1200" dirty="0">
                <a:latin typeface="Arial" panose="020B0604020202020204" pitchFamily="34" charset="0"/>
                <a:cs typeface="Arial" panose="020B0604020202020204" pitchFamily="34" charset="0"/>
              </a:rPr>
              <a:t>59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00E3E8B0-F34C-9570-12B5-7D83C4A35F1A}"/>
              </a:ext>
            </a:extLst>
          </p:cNvPr>
          <p:cNvSpPr txBox="1"/>
          <p:nvPr/>
        </p:nvSpPr>
        <p:spPr>
          <a:xfrm>
            <a:off x="4903062" y="770053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a2138</a:t>
            </a:r>
            <a:endParaRPr lang="x-non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5">
            <a:extLst>
              <a:ext uri="{FF2B5EF4-FFF2-40B4-BE49-F238E27FC236}">
                <a16:creationId xmlns:a16="http://schemas.microsoft.com/office/drawing/2014/main" id="{63E4745F-982F-2CE8-6573-2A537A47BC90}"/>
              </a:ext>
            </a:extLst>
          </p:cNvPr>
          <p:cNvSpPr txBox="1"/>
          <p:nvPr/>
        </p:nvSpPr>
        <p:spPr>
          <a:xfrm>
            <a:off x="-1269" y="64746"/>
            <a:ext cx="800219" cy="43200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RNA1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BF3ED9B5-A07D-7C2A-273F-9517D2BA6BB1}"/>
              </a:ext>
            </a:extLst>
          </p:cNvPr>
          <p:cNvCxnSpPr>
            <a:cxnSpLocks/>
          </p:cNvCxnSpPr>
          <p:nvPr/>
        </p:nvCxnSpPr>
        <p:spPr>
          <a:xfrm flipH="1">
            <a:off x="805083" y="2242160"/>
            <a:ext cx="5004000" cy="0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6" name="Group 15">
            <a:extLst>
              <a:ext uri="{FF2B5EF4-FFF2-40B4-BE49-F238E27FC236}">
                <a16:creationId xmlns:a16="http://schemas.microsoft.com/office/drawing/2014/main" id="{B943DB8E-F573-DD19-E70B-6880650DFB14}"/>
              </a:ext>
            </a:extLst>
          </p:cNvPr>
          <p:cNvGrpSpPr/>
          <p:nvPr/>
        </p:nvGrpSpPr>
        <p:grpSpPr>
          <a:xfrm>
            <a:off x="128421" y="252972"/>
            <a:ext cx="6001976" cy="3044744"/>
            <a:chOff x="128421" y="252972"/>
            <a:chExt cx="6001976" cy="3044744"/>
          </a:xfrm>
        </p:grpSpPr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6672D93E-325B-5A64-6C40-B725E05C4399}"/>
                </a:ext>
              </a:extLst>
            </p:cNvPr>
            <p:cNvGrpSpPr/>
            <p:nvPr/>
          </p:nvGrpSpPr>
          <p:grpSpPr>
            <a:xfrm>
              <a:off x="128421" y="252972"/>
              <a:ext cx="6001976" cy="2837897"/>
              <a:chOff x="128421" y="252972"/>
              <a:chExt cx="6001976" cy="2837897"/>
            </a:xfrm>
          </p:grpSpPr>
          <p:sp>
            <p:nvSpPr>
              <p:cNvPr id="13" name="正方形/長方形 12">
                <a:extLst>
                  <a:ext uri="{FF2B5EF4-FFF2-40B4-BE49-F238E27FC236}">
                    <a16:creationId xmlns:a16="http://schemas.microsoft.com/office/drawing/2014/main" id="{8AE6EB27-0FAF-B89C-9D60-118A1201E8A4}"/>
                  </a:ext>
                </a:extLst>
              </p:cNvPr>
              <p:cNvSpPr/>
              <p:nvPr/>
            </p:nvSpPr>
            <p:spPr>
              <a:xfrm rot="16200000">
                <a:off x="-379089" y="1301216"/>
                <a:ext cx="1322798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-log</a:t>
                </a:r>
                <a:r>
                  <a:rPr lang="en-US" altLang="ja-JP" sz="14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lang="en-US" altLang="ja-JP" sz="14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-value)</a:t>
                </a:r>
                <a:endParaRPr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9" name="図 8">
                <a:extLst>
                  <a:ext uri="{FF2B5EF4-FFF2-40B4-BE49-F238E27FC236}">
                    <a16:creationId xmlns:a16="http://schemas.microsoft.com/office/drawing/2014/main" id="{FF4A14D2-9B14-4871-B8B2-2898EAD6A87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430143" y="347431"/>
                <a:ext cx="5700254" cy="2743438"/>
              </a:xfrm>
              <a:prstGeom prst="rect">
                <a:avLst/>
              </a:prstGeom>
            </p:spPr>
          </p:pic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CDCFB272-D3B1-39DD-606B-7482BF7C1B3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805082" y="252972"/>
                <a:ext cx="5058000" cy="230432"/>
              </a:xfrm>
              <a:prstGeom prst="rect">
                <a:avLst/>
              </a:prstGeom>
            </p:spPr>
          </p:pic>
          <p:sp>
            <p:nvSpPr>
              <p:cNvPr id="10" name="テキスト ボックス 4">
                <a:extLst>
                  <a:ext uri="{FF2B5EF4-FFF2-40B4-BE49-F238E27FC236}">
                    <a16:creationId xmlns:a16="http://schemas.microsoft.com/office/drawing/2014/main" id="{B42BEDB6-8D76-FD20-F2CB-D7CB8AA3F44A}"/>
                  </a:ext>
                </a:extLst>
              </p:cNvPr>
              <p:cNvSpPr txBox="1"/>
              <p:nvPr/>
            </p:nvSpPr>
            <p:spPr>
              <a:xfrm>
                <a:off x="4903062" y="846582"/>
                <a:ext cx="737702" cy="230832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tIns="0" rtlCol="0">
                <a:spAutoFit/>
              </a:bodyPr>
              <a:lstStyle/>
              <a:p>
                <a:r>
                  <a:rPr kumimoji="1" lang="en-US" altLang="ja-JP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aa 2138</a:t>
                </a:r>
                <a:endParaRPr kumimoji="1" lang="ja-JP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5" name="正方形/長方形 11">
              <a:extLst>
                <a:ext uri="{FF2B5EF4-FFF2-40B4-BE49-F238E27FC236}">
                  <a16:creationId xmlns:a16="http://schemas.microsoft.com/office/drawing/2014/main" id="{48482675-E94E-7E07-8E15-0C8FDC948BC5}"/>
                </a:ext>
              </a:extLst>
            </p:cNvPr>
            <p:cNvSpPr/>
            <p:nvPr/>
          </p:nvSpPr>
          <p:spPr>
            <a:xfrm>
              <a:off x="2311546" y="2989939"/>
              <a:ext cx="2234907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Position of the amino acid</a:t>
              </a:r>
              <a:endParaRPr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B7618BE4-4545-47D8-421A-717EB0BFA796}"/>
              </a:ext>
            </a:extLst>
          </p:cNvPr>
          <p:cNvGrpSpPr/>
          <p:nvPr/>
        </p:nvGrpSpPr>
        <p:grpSpPr>
          <a:xfrm>
            <a:off x="3029" y="3423098"/>
            <a:ext cx="2896208" cy="3174375"/>
            <a:chOff x="3029" y="3423098"/>
            <a:chExt cx="2896208" cy="3174375"/>
          </a:xfrm>
        </p:grpSpPr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A2C731CE-3797-43D5-6A37-D16E3D7D110B}"/>
                </a:ext>
              </a:extLst>
            </p:cNvPr>
            <p:cNvGrpSpPr/>
            <p:nvPr/>
          </p:nvGrpSpPr>
          <p:grpSpPr>
            <a:xfrm>
              <a:off x="3029" y="3423098"/>
              <a:ext cx="2896208" cy="3174375"/>
              <a:chOff x="3029" y="2894174"/>
              <a:chExt cx="2896208" cy="3174375"/>
            </a:xfrm>
          </p:grpSpPr>
          <p:sp>
            <p:nvSpPr>
              <p:cNvPr id="28" name="正方形/長方形 11">
                <a:extLst>
                  <a:ext uri="{FF2B5EF4-FFF2-40B4-BE49-F238E27FC236}">
                    <a16:creationId xmlns:a16="http://schemas.microsoft.com/office/drawing/2014/main" id="{E67C4D9B-CE4D-4D59-E72D-BBEBE3D9EA1C}"/>
                  </a:ext>
                </a:extLst>
              </p:cNvPr>
              <p:cNvSpPr/>
              <p:nvPr/>
            </p:nvSpPr>
            <p:spPr>
              <a:xfrm>
                <a:off x="604431" y="5760772"/>
                <a:ext cx="2234907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Position of the amino acid</a:t>
                </a:r>
                <a:endParaRPr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正方形/長方形 12">
                <a:extLst>
                  <a:ext uri="{FF2B5EF4-FFF2-40B4-BE49-F238E27FC236}">
                    <a16:creationId xmlns:a16="http://schemas.microsoft.com/office/drawing/2014/main" id="{9ABF8E64-E7C4-8BA7-A420-285CAF55ADB0}"/>
                  </a:ext>
                </a:extLst>
              </p:cNvPr>
              <p:cNvSpPr/>
              <p:nvPr/>
            </p:nvSpPr>
            <p:spPr>
              <a:xfrm rot="16200000">
                <a:off x="-379089" y="4162664"/>
                <a:ext cx="1322798" cy="30777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-log</a:t>
                </a:r>
                <a:r>
                  <a:rPr lang="en-US" altLang="ja-JP" sz="14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lang="en-US" altLang="ja-JP" sz="1400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p</a:t>
                </a:r>
                <a:r>
                  <a:rPr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-value)</a:t>
                </a:r>
                <a:endParaRPr lang="ja-JP" alt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6" name="Picture 17">
                <a:extLst>
                  <a:ext uri="{FF2B5EF4-FFF2-40B4-BE49-F238E27FC236}">
                    <a16:creationId xmlns:a16="http://schemas.microsoft.com/office/drawing/2014/main" id="{B2C077BD-7135-8A5B-4257-2F1DD13426A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797763" y="3077691"/>
                <a:ext cx="1856769" cy="182483"/>
              </a:xfrm>
              <a:prstGeom prst="rect">
                <a:avLst/>
              </a:prstGeom>
            </p:spPr>
          </p:pic>
          <p:sp>
            <p:nvSpPr>
              <p:cNvPr id="26" name="テキスト ボックス 5">
                <a:extLst>
                  <a:ext uri="{FF2B5EF4-FFF2-40B4-BE49-F238E27FC236}">
                    <a16:creationId xmlns:a16="http://schemas.microsoft.com/office/drawing/2014/main" id="{6BF25DCB-9E52-B239-A9FC-728F3C54A158}"/>
                  </a:ext>
                </a:extLst>
              </p:cNvPr>
              <p:cNvSpPr txBox="1"/>
              <p:nvPr/>
            </p:nvSpPr>
            <p:spPr>
              <a:xfrm>
                <a:off x="3029" y="2894174"/>
                <a:ext cx="800219" cy="432000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dirty="0">
                    <a:latin typeface="Arial" panose="020B0604020202020204" pitchFamily="34" charset="0"/>
                    <a:cs typeface="Arial" panose="020B0604020202020204" pitchFamily="34" charset="0"/>
                  </a:rPr>
                  <a:t>RNA2</a:t>
                </a:r>
                <a:endParaRPr kumimoji="1" lang="ja-JP" altLang="en-US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3" name="図 2">
                <a:extLst>
                  <a:ext uri="{FF2B5EF4-FFF2-40B4-BE49-F238E27FC236}">
                    <a16:creationId xmlns:a16="http://schemas.microsoft.com/office/drawing/2014/main" id="{4CEDD7E9-313C-A1BE-ED6C-4A1851D9600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430143" y="3166654"/>
                <a:ext cx="2469094" cy="2743438"/>
              </a:xfrm>
              <a:prstGeom prst="rect">
                <a:avLst/>
              </a:prstGeom>
            </p:spPr>
          </p:pic>
        </p:grpSp>
        <p:cxnSp>
          <p:nvCxnSpPr>
            <p:cNvPr id="27" name="直線コネクタ 26">
              <a:extLst>
                <a:ext uri="{FF2B5EF4-FFF2-40B4-BE49-F238E27FC236}">
                  <a16:creationId xmlns:a16="http://schemas.microsoft.com/office/drawing/2014/main" id="{EA0321A8-F430-0623-106D-054D4A37FA1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10912" y="5594077"/>
              <a:ext cx="1836000" cy="0"/>
            </a:xfrm>
            <a:prstGeom prst="line">
              <a:avLst/>
            </a:prstGeom>
            <a:ln w="1270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601383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8495</TotalTime>
  <Words>31</Words>
  <Application>Microsoft Macintosh PowerPoint</Application>
  <PresentationFormat>A4 Paper (210x297 mm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dpa0934</dc:creator>
  <cp:lastModifiedBy>zhu hongjing</cp:lastModifiedBy>
  <cp:revision>57</cp:revision>
  <dcterms:created xsi:type="dcterms:W3CDTF">2023-12-25T06:24:41Z</dcterms:created>
  <dcterms:modified xsi:type="dcterms:W3CDTF">2024-05-17T03:26:19Z</dcterms:modified>
</cp:coreProperties>
</file>